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commentAuthors.xml" ContentType="application/vnd.openxmlformats-officedocument.presentationml.commentAuthor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</p:sldIdLst>
  <p:sldSz cx="6858000" cy="9906000" type="A4"/>
  <p:notesSz cx="7104063" cy="102346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ula Medina Henríquez" initials="PMH" lastIdx="1" clrIdx="0">
    <p:extLst>
      <p:ext uri="{19B8F6BF-5375-455C-9EA6-DF929625EA0E}">
        <p15:presenceInfo xmlns:p15="http://schemas.microsoft.com/office/powerpoint/2012/main" userId="87d1bd32d30c91db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232" d="100"/>
          <a:sy n="232" d="100"/>
        </p:scale>
        <p:origin x="-162" y="-24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commentAuthors" Target="commentAuthors.xml"/>
   <Relationship Id="rId4" Type="http://schemas.openxmlformats.org/officeDocument/2006/relationships/presProps" Target="presProps.xml"/>
   <Relationship Id="rId5" Type="http://schemas.openxmlformats.org/officeDocument/2006/relationships/viewProps" Target="viewProps.xml"/>
   <Relationship Id="rId6" Type="http://schemas.openxmlformats.org/officeDocument/2006/relationships/theme" Target="theme/theme1.xml"/>
   <Relationship Id="rId7" Type="http://schemas.openxmlformats.org/officeDocument/2006/relationships/tableStyles" Target="tableStyles.xml"/>
</Relationship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22D46-79ED-4B4A-B966-CFF234343466}" type="datetimeFigureOut">
              <a:rPr lang="es-ES" smtClean="0"/>
              <a:t>16/0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C90F9-6D81-463C-9989-00942A8FEA2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36216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22D46-79ED-4B4A-B966-CFF234343466}" type="datetimeFigureOut">
              <a:rPr lang="es-ES" smtClean="0"/>
              <a:t>16/0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C90F9-6D81-463C-9989-00942A8FEA2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73562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22D46-79ED-4B4A-B966-CFF234343466}" type="datetimeFigureOut">
              <a:rPr lang="es-ES" smtClean="0"/>
              <a:t>16/0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C90F9-6D81-463C-9989-00942A8FEA2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2732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22D46-79ED-4B4A-B966-CFF234343466}" type="datetimeFigureOut">
              <a:rPr lang="es-ES" smtClean="0"/>
              <a:t>16/0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C90F9-6D81-463C-9989-00942A8FEA2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14922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22D46-79ED-4B4A-B966-CFF234343466}" type="datetimeFigureOut">
              <a:rPr lang="es-ES" smtClean="0"/>
              <a:t>16/0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C90F9-6D81-463C-9989-00942A8FEA2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73197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22D46-79ED-4B4A-B966-CFF234343466}" type="datetimeFigureOut">
              <a:rPr lang="es-ES" smtClean="0"/>
              <a:t>16/01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C90F9-6D81-463C-9989-00942A8FEA2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905636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22D46-79ED-4B4A-B966-CFF234343466}" type="datetimeFigureOut">
              <a:rPr lang="es-ES" smtClean="0"/>
              <a:t>16/01/2019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C90F9-6D81-463C-9989-00942A8FEA2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570915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22D46-79ED-4B4A-B966-CFF234343466}" type="datetimeFigureOut">
              <a:rPr lang="es-ES" smtClean="0"/>
              <a:t>16/01/2019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C90F9-6D81-463C-9989-00942A8FEA2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991208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22D46-79ED-4B4A-B966-CFF234343466}" type="datetimeFigureOut">
              <a:rPr lang="es-ES" smtClean="0"/>
              <a:t>16/01/2019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C90F9-6D81-463C-9989-00942A8FEA2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273291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22D46-79ED-4B4A-B966-CFF234343466}" type="datetimeFigureOut">
              <a:rPr lang="es-ES" smtClean="0"/>
              <a:t>16/01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C90F9-6D81-463C-9989-00942A8FEA2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1997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22D46-79ED-4B4A-B966-CFF234343466}" type="datetimeFigureOut">
              <a:rPr lang="es-ES" smtClean="0"/>
              <a:t>16/01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0C90F9-6D81-463C-9989-00942A8FEA2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92927613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422D46-79ED-4B4A-B966-CFF234343466}" type="datetimeFigureOut">
              <a:rPr lang="es-ES" smtClean="0"/>
              <a:t>16/01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0C90F9-6D81-463C-9989-00942A8FEA2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58387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08" name="Conector recto de flecha 207"/>
          <p:cNvCxnSpPr/>
          <p:nvPr/>
        </p:nvCxnSpPr>
        <p:spPr>
          <a:xfrm flipV="1">
            <a:off x="2630492" y="5329411"/>
            <a:ext cx="763" cy="144000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6" name="Tabla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47546793"/>
              </p:ext>
            </p:extLst>
          </p:nvPr>
        </p:nvGraphicFramePr>
        <p:xfrm>
          <a:off x="849975" y="1820059"/>
          <a:ext cx="3298793" cy="26746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2912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1352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9466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6147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61938">
                <a:tc>
                  <a:txBody>
                    <a:bodyPr/>
                    <a:lstStyle/>
                    <a:p>
                      <a:r>
                        <a:rPr lang="es-ES" sz="1000" b="1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bp4</a:t>
                      </a:r>
                      <a:endParaRPr lang="es-ES" sz="1000" b="1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61938">
                <a:tc>
                  <a:txBody>
                    <a:bodyPr/>
                    <a:lstStyle/>
                    <a:p>
                      <a:r>
                        <a:rPr lang="es-ES" sz="1000" b="1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a6</a:t>
                      </a:r>
                      <a:endParaRPr lang="es-ES" sz="1000" b="1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61938">
                <a:tc>
                  <a:txBody>
                    <a:bodyPr/>
                    <a:lstStyle/>
                    <a:p>
                      <a:r>
                        <a:rPr lang="es-ES" sz="1000" b="1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dh1a2</a:t>
                      </a:r>
                      <a:endParaRPr lang="es-ES" sz="1000" b="1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61938">
                <a:tc>
                  <a:txBody>
                    <a:bodyPr/>
                    <a:lstStyle/>
                    <a:p>
                      <a:r>
                        <a:rPr lang="es-ES" sz="1000" b="1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dh1a3</a:t>
                      </a:r>
                      <a:endParaRPr lang="es-ES" sz="1000" b="1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61938">
                <a:tc>
                  <a:txBody>
                    <a:bodyPr/>
                    <a:lstStyle/>
                    <a:p>
                      <a:r>
                        <a:rPr lang="es-ES" sz="1000" b="1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abp1</a:t>
                      </a:r>
                      <a:endParaRPr lang="es-ES" sz="1000" b="1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61938">
                <a:tc>
                  <a:txBody>
                    <a:bodyPr/>
                    <a:lstStyle/>
                    <a:p>
                      <a:r>
                        <a:rPr lang="es-ES" sz="1000" b="1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p26a1</a:t>
                      </a:r>
                      <a:endParaRPr lang="es-ES" sz="1000" b="1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61938">
                <a:tc>
                  <a:txBody>
                    <a:bodyPr/>
                    <a:lstStyle/>
                    <a:p>
                      <a:r>
                        <a:rPr lang="es-ES" sz="1000" b="1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ra</a:t>
                      </a:r>
                      <a:endParaRPr lang="es-ES" sz="1000" b="1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61938">
                <a:tc>
                  <a:txBody>
                    <a:bodyPr/>
                    <a:lstStyle/>
                    <a:p>
                      <a:r>
                        <a:rPr lang="es-ES" sz="1000" b="1" i="1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xra</a:t>
                      </a:r>
                      <a:endParaRPr lang="es-ES" sz="1000" b="1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61938">
                <a:tc>
                  <a:txBody>
                    <a:bodyPr/>
                    <a:lstStyle/>
                    <a:p>
                      <a:r>
                        <a:rPr lang="es-ES" sz="1000" b="1" i="1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arg</a:t>
                      </a:r>
                      <a:endParaRPr lang="es-ES" sz="1000" b="1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310" name="Flecha abajo 309"/>
          <p:cNvSpPr/>
          <p:nvPr/>
        </p:nvSpPr>
        <p:spPr>
          <a:xfrm rot="16200000">
            <a:off x="3058451" y="1900243"/>
            <a:ext cx="136573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11" name="Flecha abajo 310"/>
          <p:cNvSpPr/>
          <p:nvPr/>
        </p:nvSpPr>
        <p:spPr>
          <a:xfrm rot="16200000">
            <a:off x="3058451" y="2795981"/>
            <a:ext cx="136573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12" name="Flecha abajo 311"/>
          <p:cNvSpPr/>
          <p:nvPr/>
        </p:nvSpPr>
        <p:spPr>
          <a:xfrm rot="16200000">
            <a:off x="2122596" y="2508202"/>
            <a:ext cx="136573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13" name="Flecha abajo 312"/>
          <p:cNvSpPr/>
          <p:nvPr/>
        </p:nvSpPr>
        <p:spPr>
          <a:xfrm rot="16200000">
            <a:off x="2122596" y="3096485"/>
            <a:ext cx="136573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14" name="Flecha abajo 313"/>
          <p:cNvSpPr/>
          <p:nvPr/>
        </p:nvSpPr>
        <p:spPr>
          <a:xfrm rot="16200000">
            <a:off x="2122596" y="3693180"/>
            <a:ext cx="136573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15" name="Flecha abajo 314"/>
          <p:cNvSpPr/>
          <p:nvPr/>
        </p:nvSpPr>
        <p:spPr>
          <a:xfrm rot="16200000">
            <a:off x="2122596" y="3986962"/>
            <a:ext cx="136573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4" name="Flecha abajo 353"/>
          <p:cNvSpPr/>
          <p:nvPr/>
        </p:nvSpPr>
        <p:spPr>
          <a:xfrm>
            <a:off x="3850481" y="1900243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5" name="Flecha abajo 354"/>
          <p:cNvSpPr/>
          <p:nvPr/>
        </p:nvSpPr>
        <p:spPr>
          <a:xfrm flipV="1">
            <a:off x="2122596" y="1900243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6" name="Flecha abajo 355"/>
          <p:cNvSpPr/>
          <p:nvPr/>
        </p:nvSpPr>
        <p:spPr>
          <a:xfrm>
            <a:off x="3850481" y="2210065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7" name="Flecha abajo 356"/>
          <p:cNvSpPr/>
          <p:nvPr/>
        </p:nvSpPr>
        <p:spPr>
          <a:xfrm>
            <a:off x="3850481" y="2505997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8" name="Flecha abajo 357"/>
          <p:cNvSpPr/>
          <p:nvPr/>
        </p:nvSpPr>
        <p:spPr>
          <a:xfrm>
            <a:off x="3850481" y="2799877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9" name="Flecha abajo 358"/>
          <p:cNvSpPr/>
          <p:nvPr/>
        </p:nvSpPr>
        <p:spPr>
          <a:xfrm>
            <a:off x="3850481" y="3095809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0" name="Flecha abajo 359"/>
          <p:cNvSpPr/>
          <p:nvPr/>
        </p:nvSpPr>
        <p:spPr>
          <a:xfrm>
            <a:off x="3850481" y="3387590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1" name="Flecha abajo 360"/>
          <p:cNvSpPr/>
          <p:nvPr/>
        </p:nvSpPr>
        <p:spPr>
          <a:xfrm>
            <a:off x="3850481" y="3701825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2" name="Flecha abajo 361"/>
          <p:cNvSpPr/>
          <p:nvPr/>
        </p:nvSpPr>
        <p:spPr>
          <a:xfrm>
            <a:off x="3850481" y="3984287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3" name="Flecha abajo 362"/>
          <p:cNvSpPr/>
          <p:nvPr/>
        </p:nvSpPr>
        <p:spPr>
          <a:xfrm>
            <a:off x="3850481" y="4291567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4" name="Flecha abajo 363"/>
          <p:cNvSpPr/>
          <p:nvPr/>
        </p:nvSpPr>
        <p:spPr>
          <a:xfrm>
            <a:off x="3058451" y="3093037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6" name="Flecha abajo 365"/>
          <p:cNvSpPr/>
          <p:nvPr/>
        </p:nvSpPr>
        <p:spPr>
          <a:xfrm flipV="1">
            <a:off x="2122596" y="2795980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7" name="Flecha abajo 366"/>
          <p:cNvSpPr/>
          <p:nvPr/>
        </p:nvSpPr>
        <p:spPr>
          <a:xfrm flipV="1">
            <a:off x="2122596" y="3387592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9" name="Flecha abajo 368"/>
          <p:cNvSpPr/>
          <p:nvPr/>
        </p:nvSpPr>
        <p:spPr>
          <a:xfrm flipV="1">
            <a:off x="2122596" y="2204870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0" name="Flecha abajo 369"/>
          <p:cNvSpPr/>
          <p:nvPr/>
        </p:nvSpPr>
        <p:spPr>
          <a:xfrm flipV="1">
            <a:off x="3058451" y="2199675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1" name="Flecha abajo 370"/>
          <p:cNvSpPr/>
          <p:nvPr/>
        </p:nvSpPr>
        <p:spPr>
          <a:xfrm flipV="1">
            <a:off x="3058451" y="2492320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2" name="Flecha abajo 371"/>
          <p:cNvSpPr/>
          <p:nvPr/>
        </p:nvSpPr>
        <p:spPr>
          <a:xfrm flipV="1">
            <a:off x="3058451" y="3387591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3" name="Flecha abajo 372"/>
          <p:cNvSpPr/>
          <p:nvPr/>
        </p:nvSpPr>
        <p:spPr>
          <a:xfrm flipV="1">
            <a:off x="3058451" y="3696072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4" name="Flecha abajo 373"/>
          <p:cNvSpPr/>
          <p:nvPr/>
        </p:nvSpPr>
        <p:spPr>
          <a:xfrm flipV="1">
            <a:off x="3058451" y="3984287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5" name="Flecha abajo 374"/>
          <p:cNvSpPr/>
          <p:nvPr/>
        </p:nvSpPr>
        <p:spPr>
          <a:xfrm flipV="1">
            <a:off x="2122596" y="4287540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6" name="Flecha abajo 375"/>
          <p:cNvSpPr/>
          <p:nvPr/>
        </p:nvSpPr>
        <p:spPr>
          <a:xfrm flipV="1">
            <a:off x="3058451" y="4291567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5" name="CuadroTexto 104"/>
          <p:cNvSpPr txBox="1"/>
          <p:nvPr/>
        </p:nvSpPr>
        <p:spPr>
          <a:xfrm>
            <a:off x="1819839" y="1469352"/>
            <a:ext cx="383265" cy="2154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T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CuadroTexto 105"/>
          <p:cNvSpPr txBox="1"/>
          <p:nvPr/>
        </p:nvSpPr>
        <p:spPr>
          <a:xfrm>
            <a:off x="2137344" y="1463036"/>
            <a:ext cx="387675" cy="2154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dT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CuadroTexto 109"/>
          <p:cNvSpPr txBox="1"/>
          <p:nvPr/>
        </p:nvSpPr>
        <p:spPr>
          <a:xfrm>
            <a:off x="3670457" y="1321481"/>
            <a:ext cx="5212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T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CuadroTexto 119"/>
          <p:cNvSpPr txBox="1"/>
          <p:nvPr/>
        </p:nvSpPr>
        <p:spPr>
          <a:xfrm>
            <a:off x="765315" y="5132074"/>
            <a:ext cx="728875" cy="2154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emales</a:t>
            </a:r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CuadroTexto 121"/>
          <p:cNvSpPr txBox="1"/>
          <p:nvPr/>
        </p:nvSpPr>
        <p:spPr>
          <a:xfrm>
            <a:off x="5077230" y="4992363"/>
            <a:ext cx="7067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turatio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CuadroTexto 130"/>
          <p:cNvSpPr txBox="1"/>
          <p:nvPr/>
        </p:nvSpPr>
        <p:spPr>
          <a:xfrm>
            <a:off x="5590808" y="4995497"/>
            <a:ext cx="695622" cy="2154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vulatio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CuadroTexto 117"/>
          <p:cNvSpPr txBox="1"/>
          <p:nvPr/>
        </p:nvSpPr>
        <p:spPr>
          <a:xfrm>
            <a:off x="2596073" y="4998686"/>
            <a:ext cx="1691857" cy="2154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algn="ct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sz="800" dirty="0" err="1" smtClean="0"/>
              <a:t>Previtellogenesis</a:t>
            </a:r>
            <a:endParaRPr lang="es-ES" sz="800" dirty="0"/>
          </a:p>
        </p:txBody>
      </p:sp>
      <p:sp>
        <p:nvSpPr>
          <p:cNvPr id="116" name="CuadroTexto 115"/>
          <p:cNvSpPr txBox="1"/>
          <p:nvPr/>
        </p:nvSpPr>
        <p:spPr>
          <a:xfrm>
            <a:off x="1732116" y="5152324"/>
            <a:ext cx="425845" cy="2154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algn="ct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sz="800" dirty="0" err="1" smtClean="0"/>
              <a:t>UnO</a:t>
            </a:r>
            <a:endParaRPr lang="es-ES" sz="800" dirty="0"/>
          </a:p>
        </p:txBody>
      </p:sp>
      <p:sp>
        <p:nvSpPr>
          <p:cNvPr id="117" name="CuadroTexto 116"/>
          <p:cNvSpPr txBox="1"/>
          <p:nvPr/>
        </p:nvSpPr>
        <p:spPr>
          <a:xfrm>
            <a:off x="2050172" y="5152324"/>
            <a:ext cx="464573" cy="2154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s-E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CuadroTexto 118"/>
          <p:cNvSpPr txBox="1"/>
          <p:nvPr/>
        </p:nvSpPr>
        <p:spPr>
          <a:xfrm>
            <a:off x="4378758" y="4998686"/>
            <a:ext cx="823607" cy="2154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Vitellogenesi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CuadroTexto 107"/>
          <p:cNvSpPr txBox="1"/>
          <p:nvPr/>
        </p:nvSpPr>
        <p:spPr>
          <a:xfrm>
            <a:off x="2464374" y="1315280"/>
            <a:ext cx="13124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dT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8" name="CuadroTexto 237"/>
          <p:cNvSpPr txBox="1"/>
          <p:nvPr/>
        </p:nvSpPr>
        <p:spPr>
          <a:xfrm>
            <a:off x="1649047" y="4993663"/>
            <a:ext cx="10039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algn="ct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sz="800" dirty="0" smtClean="0"/>
              <a:t>Sex </a:t>
            </a:r>
            <a:r>
              <a:rPr lang="es-ES" sz="800" dirty="0" err="1" smtClean="0"/>
              <a:t>differentiation</a:t>
            </a:r>
            <a:endParaRPr lang="es-ES" sz="800" dirty="0"/>
          </a:p>
        </p:txBody>
      </p:sp>
      <p:sp>
        <p:nvSpPr>
          <p:cNvPr id="24" name="Cerrar corchete 23"/>
          <p:cNvSpPr/>
          <p:nvPr/>
        </p:nvSpPr>
        <p:spPr>
          <a:xfrm rot="16200000">
            <a:off x="3425869" y="4268624"/>
            <a:ext cx="55579" cy="1876221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graphicFrame>
        <p:nvGraphicFramePr>
          <p:cNvPr id="287" name="Tabla 28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1271091"/>
              </p:ext>
            </p:extLst>
          </p:nvPr>
        </p:nvGraphicFramePr>
        <p:xfrm>
          <a:off x="845043" y="5482287"/>
          <a:ext cx="5222329" cy="26746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5866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0007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92280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3435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22201">
                  <a:extLst>
                    <a:ext uri="{9D8B030D-6E8A-4147-A177-3AD203B41FA5}">
                      <a16:colId xmlns:a16="http://schemas.microsoft.com/office/drawing/2014/main" val="500795828"/>
                    </a:ext>
                  </a:extLst>
                </a:gridCol>
                <a:gridCol w="384237">
                  <a:extLst>
                    <a:ext uri="{9D8B030D-6E8A-4147-A177-3AD203B41FA5}">
                      <a16:colId xmlns:a16="http://schemas.microsoft.com/office/drawing/2014/main" val="263962751"/>
                    </a:ext>
                  </a:extLst>
                </a:gridCol>
              </a:tblGrid>
              <a:tr h="261938">
                <a:tc>
                  <a:txBody>
                    <a:bodyPr/>
                    <a:lstStyle/>
                    <a:p>
                      <a:r>
                        <a:rPr lang="es-ES" sz="1000" b="1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bp4</a:t>
                      </a:r>
                      <a:endParaRPr lang="es-ES" sz="1000" b="1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61938">
                <a:tc>
                  <a:txBody>
                    <a:bodyPr/>
                    <a:lstStyle/>
                    <a:p>
                      <a:r>
                        <a:rPr lang="es-ES" sz="1000" b="1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ra6</a:t>
                      </a:r>
                      <a:endParaRPr lang="es-ES" sz="1000" b="1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61938">
                <a:tc>
                  <a:txBody>
                    <a:bodyPr/>
                    <a:lstStyle/>
                    <a:p>
                      <a:r>
                        <a:rPr lang="es-ES" sz="1000" b="1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dh1a2</a:t>
                      </a:r>
                      <a:endParaRPr lang="es-ES" sz="1000" b="1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61938">
                <a:tc>
                  <a:txBody>
                    <a:bodyPr/>
                    <a:lstStyle/>
                    <a:p>
                      <a:r>
                        <a:rPr lang="es-ES" sz="1000" b="1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dh1a3</a:t>
                      </a:r>
                      <a:endParaRPr lang="es-ES" sz="1000" b="1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61938">
                <a:tc>
                  <a:txBody>
                    <a:bodyPr/>
                    <a:lstStyle/>
                    <a:p>
                      <a:r>
                        <a:rPr lang="es-ES" sz="1000" b="1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abp1</a:t>
                      </a:r>
                      <a:endParaRPr lang="es-ES" sz="1000" b="1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61938">
                <a:tc>
                  <a:txBody>
                    <a:bodyPr/>
                    <a:lstStyle/>
                    <a:p>
                      <a:r>
                        <a:rPr lang="es-ES" sz="1000" b="1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p26a1</a:t>
                      </a:r>
                      <a:endParaRPr lang="es-ES" sz="1000" b="1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61938">
                <a:tc>
                  <a:txBody>
                    <a:bodyPr/>
                    <a:lstStyle/>
                    <a:p>
                      <a:r>
                        <a:rPr lang="es-ES" sz="1000" b="1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ra</a:t>
                      </a:r>
                      <a:endParaRPr lang="es-ES" sz="1000" b="1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61938">
                <a:tc>
                  <a:txBody>
                    <a:bodyPr/>
                    <a:lstStyle/>
                    <a:p>
                      <a:r>
                        <a:rPr lang="es-ES" sz="1000" b="1" i="1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xra</a:t>
                      </a:r>
                      <a:endParaRPr lang="es-ES" sz="1000" b="1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61938">
                <a:tc>
                  <a:txBody>
                    <a:bodyPr/>
                    <a:lstStyle/>
                    <a:p>
                      <a:r>
                        <a:rPr lang="es-ES" sz="1000" b="1" i="1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parg</a:t>
                      </a:r>
                      <a:endParaRPr lang="es-ES" sz="1000" b="1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es-E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218" name="Flecha abajo 217"/>
          <p:cNvSpPr/>
          <p:nvPr/>
        </p:nvSpPr>
        <p:spPr>
          <a:xfrm rot="16200000">
            <a:off x="2084726" y="5566034"/>
            <a:ext cx="136573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19" name="Flecha abajo 218"/>
          <p:cNvSpPr/>
          <p:nvPr/>
        </p:nvSpPr>
        <p:spPr>
          <a:xfrm rot="16200000">
            <a:off x="3403847" y="5566034"/>
            <a:ext cx="136573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2" name="Flecha abajo 221"/>
          <p:cNvSpPr/>
          <p:nvPr/>
        </p:nvSpPr>
        <p:spPr>
          <a:xfrm rot="16200000">
            <a:off x="5406896" y="5566033"/>
            <a:ext cx="136573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4" name="Flecha abajo 223"/>
          <p:cNvSpPr/>
          <p:nvPr/>
        </p:nvSpPr>
        <p:spPr>
          <a:xfrm rot="16200000">
            <a:off x="2084726" y="6760999"/>
            <a:ext cx="136573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5" name="Flecha abajo 224"/>
          <p:cNvSpPr/>
          <p:nvPr/>
        </p:nvSpPr>
        <p:spPr>
          <a:xfrm rot="16200000">
            <a:off x="2084726" y="7957819"/>
            <a:ext cx="136573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6" name="Flecha abajo 225"/>
          <p:cNvSpPr/>
          <p:nvPr/>
        </p:nvSpPr>
        <p:spPr>
          <a:xfrm rot="16200000">
            <a:off x="3403847" y="6461583"/>
            <a:ext cx="136573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7" name="Flecha abajo 226"/>
          <p:cNvSpPr/>
          <p:nvPr/>
        </p:nvSpPr>
        <p:spPr>
          <a:xfrm rot="16200000">
            <a:off x="5406896" y="6754040"/>
            <a:ext cx="136573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8" name="Flecha abajo 227"/>
          <p:cNvSpPr/>
          <p:nvPr/>
        </p:nvSpPr>
        <p:spPr>
          <a:xfrm rot="16200000">
            <a:off x="5399961" y="7957123"/>
            <a:ext cx="136573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9" name="Flecha abajo 228"/>
          <p:cNvSpPr/>
          <p:nvPr/>
        </p:nvSpPr>
        <p:spPr>
          <a:xfrm rot="16200000">
            <a:off x="5815968" y="5871937"/>
            <a:ext cx="124157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0" name="Flecha abajo 229"/>
          <p:cNvSpPr/>
          <p:nvPr/>
        </p:nvSpPr>
        <p:spPr>
          <a:xfrm rot="16200000">
            <a:off x="5815967" y="6166602"/>
            <a:ext cx="124157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1" name="Flecha abajo 230"/>
          <p:cNvSpPr/>
          <p:nvPr/>
        </p:nvSpPr>
        <p:spPr>
          <a:xfrm rot="16200000">
            <a:off x="5810619" y="6759491"/>
            <a:ext cx="124157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2" name="Flecha abajo 231"/>
          <p:cNvSpPr/>
          <p:nvPr/>
        </p:nvSpPr>
        <p:spPr>
          <a:xfrm rot="16200000">
            <a:off x="5810618" y="7051227"/>
            <a:ext cx="124157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3" name="Flecha abajo 232"/>
          <p:cNvSpPr/>
          <p:nvPr/>
        </p:nvSpPr>
        <p:spPr>
          <a:xfrm rot="16200000">
            <a:off x="5814303" y="7356071"/>
            <a:ext cx="124157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4" name="Flecha abajo 233"/>
          <p:cNvSpPr/>
          <p:nvPr/>
        </p:nvSpPr>
        <p:spPr>
          <a:xfrm rot="16200000">
            <a:off x="5814303" y="7653247"/>
            <a:ext cx="124157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50" name="Flecha abajo 249"/>
          <p:cNvSpPr/>
          <p:nvPr/>
        </p:nvSpPr>
        <p:spPr>
          <a:xfrm rot="16200000">
            <a:off x="4796558" y="6166901"/>
            <a:ext cx="136573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3" name="Flecha abajo 322"/>
          <p:cNvSpPr/>
          <p:nvPr/>
        </p:nvSpPr>
        <p:spPr>
          <a:xfrm>
            <a:off x="5406895" y="5855958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4" name="Flecha abajo 323"/>
          <p:cNvSpPr/>
          <p:nvPr/>
        </p:nvSpPr>
        <p:spPr>
          <a:xfrm>
            <a:off x="5406895" y="6166900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5" name="Flecha abajo 324"/>
          <p:cNvSpPr/>
          <p:nvPr/>
        </p:nvSpPr>
        <p:spPr>
          <a:xfrm>
            <a:off x="5406895" y="6454190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6" name="Flecha abajo 325"/>
          <p:cNvSpPr/>
          <p:nvPr/>
        </p:nvSpPr>
        <p:spPr>
          <a:xfrm>
            <a:off x="5406895" y="7058620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7" name="Flecha abajo 326"/>
          <p:cNvSpPr/>
          <p:nvPr/>
        </p:nvSpPr>
        <p:spPr>
          <a:xfrm>
            <a:off x="5406895" y="7353534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8" name="Flecha abajo 327"/>
          <p:cNvSpPr/>
          <p:nvPr/>
        </p:nvSpPr>
        <p:spPr>
          <a:xfrm>
            <a:off x="5406895" y="7652705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9" name="Flecha abajo 328"/>
          <p:cNvSpPr/>
          <p:nvPr/>
        </p:nvSpPr>
        <p:spPr>
          <a:xfrm>
            <a:off x="4796558" y="7957819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0" name="Flecha abajo 329"/>
          <p:cNvSpPr/>
          <p:nvPr/>
        </p:nvSpPr>
        <p:spPr>
          <a:xfrm>
            <a:off x="4796558" y="7653247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1" name="Flecha abajo 330"/>
          <p:cNvSpPr/>
          <p:nvPr/>
        </p:nvSpPr>
        <p:spPr>
          <a:xfrm>
            <a:off x="4796558" y="7356071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2" name="Flecha abajo 331"/>
          <p:cNvSpPr/>
          <p:nvPr/>
        </p:nvSpPr>
        <p:spPr>
          <a:xfrm>
            <a:off x="4796558" y="7058620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3" name="Flecha abajo 332"/>
          <p:cNvSpPr/>
          <p:nvPr/>
        </p:nvSpPr>
        <p:spPr>
          <a:xfrm>
            <a:off x="4796558" y="6761000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4" name="Flecha abajo 333"/>
          <p:cNvSpPr/>
          <p:nvPr/>
        </p:nvSpPr>
        <p:spPr>
          <a:xfrm>
            <a:off x="4796558" y="6461583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5" name="Flecha abajo 334"/>
          <p:cNvSpPr/>
          <p:nvPr/>
        </p:nvSpPr>
        <p:spPr>
          <a:xfrm>
            <a:off x="4796558" y="5566034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6" name="Flecha abajo 335"/>
          <p:cNvSpPr/>
          <p:nvPr/>
        </p:nvSpPr>
        <p:spPr>
          <a:xfrm>
            <a:off x="4796558" y="5871938"/>
            <a:ext cx="136573" cy="131225"/>
          </a:xfrm>
          <a:prstGeom prst="downArrow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7" name="Flecha abajo 336"/>
          <p:cNvSpPr/>
          <p:nvPr/>
        </p:nvSpPr>
        <p:spPr>
          <a:xfrm flipV="1">
            <a:off x="5812434" y="5556552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8" name="Flecha abajo 337"/>
          <p:cNvSpPr/>
          <p:nvPr/>
        </p:nvSpPr>
        <p:spPr>
          <a:xfrm flipV="1">
            <a:off x="5807085" y="6461582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9" name="Flecha abajo 338"/>
          <p:cNvSpPr/>
          <p:nvPr/>
        </p:nvSpPr>
        <p:spPr>
          <a:xfrm flipV="1">
            <a:off x="5808095" y="7957819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0" name="Flecha abajo 339"/>
          <p:cNvSpPr/>
          <p:nvPr/>
        </p:nvSpPr>
        <p:spPr>
          <a:xfrm flipV="1">
            <a:off x="3403847" y="5871938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1" name="Flecha abajo 340"/>
          <p:cNvSpPr/>
          <p:nvPr/>
        </p:nvSpPr>
        <p:spPr>
          <a:xfrm flipV="1">
            <a:off x="3403847" y="6166901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2" name="Flecha abajo 341"/>
          <p:cNvSpPr/>
          <p:nvPr/>
        </p:nvSpPr>
        <p:spPr>
          <a:xfrm flipV="1">
            <a:off x="3403847" y="6761000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3" name="Flecha abajo 342"/>
          <p:cNvSpPr/>
          <p:nvPr/>
        </p:nvSpPr>
        <p:spPr>
          <a:xfrm flipV="1">
            <a:off x="3403847" y="7058620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4" name="Flecha abajo 343"/>
          <p:cNvSpPr/>
          <p:nvPr/>
        </p:nvSpPr>
        <p:spPr>
          <a:xfrm flipV="1">
            <a:off x="3403847" y="7356071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5" name="Flecha abajo 344"/>
          <p:cNvSpPr/>
          <p:nvPr/>
        </p:nvSpPr>
        <p:spPr>
          <a:xfrm flipV="1">
            <a:off x="3403847" y="7653247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6" name="Flecha abajo 345"/>
          <p:cNvSpPr/>
          <p:nvPr/>
        </p:nvSpPr>
        <p:spPr>
          <a:xfrm flipV="1">
            <a:off x="3403847" y="7957819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7" name="Flecha abajo 346"/>
          <p:cNvSpPr/>
          <p:nvPr/>
        </p:nvSpPr>
        <p:spPr>
          <a:xfrm flipV="1">
            <a:off x="2084726" y="5871938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0" name="Flecha abajo 349"/>
          <p:cNvSpPr/>
          <p:nvPr/>
        </p:nvSpPr>
        <p:spPr>
          <a:xfrm flipV="1">
            <a:off x="2084726" y="7058620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1" name="Flecha abajo 350"/>
          <p:cNvSpPr/>
          <p:nvPr/>
        </p:nvSpPr>
        <p:spPr>
          <a:xfrm flipV="1">
            <a:off x="2084726" y="7356071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2" name="Flecha abajo 351"/>
          <p:cNvSpPr/>
          <p:nvPr/>
        </p:nvSpPr>
        <p:spPr>
          <a:xfrm flipV="1">
            <a:off x="2084726" y="7653247"/>
            <a:ext cx="136573" cy="131225"/>
          </a:xfrm>
          <a:prstGeom prst="down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88" name="Flecha abajo 187"/>
          <p:cNvSpPr/>
          <p:nvPr/>
        </p:nvSpPr>
        <p:spPr>
          <a:xfrm rot="16200000">
            <a:off x="2086710" y="6452613"/>
            <a:ext cx="136573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89" name="Flecha abajo 188"/>
          <p:cNvSpPr/>
          <p:nvPr/>
        </p:nvSpPr>
        <p:spPr>
          <a:xfrm rot="16200000">
            <a:off x="2086718" y="6172905"/>
            <a:ext cx="136573" cy="131225"/>
          </a:xfrm>
          <a:prstGeom prst="downArrow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40" name="CuadroTexto 239"/>
          <p:cNvSpPr txBox="1"/>
          <p:nvPr/>
        </p:nvSpPr>
        <p:spPr>
          <a:xfrm>
            <a:off x="1648381" y="1312768"/>
            <a:ext cx="10039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"/>
            </a:defPPr>
            <a:lvl1pPr algn="ctr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s-ES" sz="800" dirty="0" smtClean="0"/>
              <a:t>Sex </a:t>
            </a:r>
            <a:r>
              <a:rPr lang="es-ES" sz="800" dirty="0" err="1" smtClean="0"/>
              <a:t>differentiation</a:t>
            </a:r>
            <a:endParaRPr lang="es-ES" sz="800" dirty="0"/>
          </a:p>
        </p:txBody>
      </p:sp>
      <p:sp>
        <p:nvSpPr>
          <p:cNvPr id="127" name="Cerrar corchete 126"/>
          <p:cNvSpPr/>
          <p:nvPr/>
        </p:nvSpPr>
        <p:spPr>
          <a:xfrm rot="16200000">
            <a:off x="4801097" y="4800829"/>
            <a:ext cx="55848" cy="811413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8" name="Cerrar corchete 127"/>
          <p:cNvSpPr/>
          <p:nvPr/>
        </p:nvSpPr>
        <p:spPr>
          <a:xfrm rot="16200000">
            <a:off x="2116040" y="4860797"/>
            <a:ext cx="55566" cy="690613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138" name="Conector recto de flecha 137"/>
          <p:cNvCxnSpPr/>
          <p:nvPr/>
        </p:nvCxnSpPr>
        <p:spPr>
          <a:xfrm flipV="1">
            <a:off x="2273892" y="5329411"/>
            <a:ext cx="763" cy="144000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Conector recto de flecha 138"/>
          <p:cNvCxnSpPr/>
          <p:nvPr/>
        </p:nvCxnSpPr>
        <p:spPr>
          <a:xfrm flipV="1">
            <a:off x="1930599" y="5329411"/>
            <a:ext cx="763" cy="144000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Conector recto de flecha 139"/>
          <p:cNvCxnSpPr/>
          <p:nvPr/>
        </p:nvCxnSpPr>
        <p:spPr>
          <a:xfrm flipV="1">
            <a:off x="3067326" y="5329411"/>
            <a:ext cx="763" cy="144000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Conector recto de flecha 140"/>
          <p:cNvCxnSpPr/>
          <p:nvPr/>
        </p:nvCxnSpPr>
        <p:spPr>
          <a:xfrm flipV="1">
            <a:off x="3450825" y="5329411"/>
            <a:ext cx="763" cy="144000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Conector recto de flecha 141"/>
          <p:cNvCxnSpPr/>
          <p:nvPr/>
        </p:nvCxnSpPr>
        <p:spPr>
          <a:xfrm flipV="1">
            <a:off x="3861386" y="5329411"/>
            <a:ext cx="763" cy="144000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Conector recto de flecha 142"/>
          <p:cNvCxnSpPr/>
          <p:nvPr/>
        </p:nvCxnSpPr>
        <p:spPr>
          <a:xfrm flipV="1">
            <a:off x="4263052" y="5329411"/>
            <a:ext cx="763" cy="144000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Conector recto de flecha 143"/>
          <p:cNvCxnSpPr/>
          <p:nvPr/>
        </p:nvCxnSpPr>
        <p:spPr>
          <a:xfrm flipV="1">
            <a:off x="4696174" y="5329411"/>
            <a:ext cx="763" cy="144000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Conector recto de flecha 144"/>
          <p:cNvCxnSpPr/>
          <p:nvPr/>
        </p:nvCxnSpPr>
        <p:spPr>
          <a:xfrm flipV="1">
            <a:off x="5078910" y="5329411"/>
            <a:ext cx="763" cy="144000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Conector recto de flecha 145"/>
          <p:cNvCxnSpPr/>
          <p:nvPr/>
        </p:nvCxnSpPr>
        <p:spPr>
          <a:xfrm flipV="1">
            <a:off x="5468522" y="5329411"/>
            <a:ext cx="763" cy="144000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Conector recto de flecha 146"/>
          <p:cNvCxnSpPr/>
          <p:nvPr/>
        </p:nvCxnSpPr>
        <p:spPr>
          <a:xfrm flipV="1">
            <a:off x="5857736" y="5329411"/>
            <a:ext cx="763" cy="144000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Conector recto de flecha 147"/>
          <p:cNvCxnSpPr/>
          <p:nvPr/>
        </p:nvCxnSpPr>
        <p:spPr>
          <a:xfrm flipV="1">
            <a:off x="3927230" y="1660246"/>
            <a:ext cx="763" cy="144000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Conector recto de flecha 148"/>
          <p:cNvCxnSpPr/>
          <p:nvPr/>
        </p:nvCxnSpPr>
        <p:spPr>
          <a:xfrm flipV="1">
            <a:off x="3522356" y="1660246"/>
            <a:ext cx="763" cy="144000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Conector recto de flecha 150"/>
          <p:cNvCxnSpPr/>
          <p:nvPr/>
        </p:nvCxnSpPr>
        <p:spPr>
          <a:xfrm flipV="1">
            <a:off x="3133918" y="1667451"/>
            <a:ext cx="763" cy="144000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Conector recto de flecha 151"/>
          <p:cNvCxnSpPr/>
          <p:nvPr/>
        </p:nvCxnSpPr>
        <p:spPr>
          <a:xfrm flipV="1">
            <a:off x="2712924" y="1663733"/>
            <a:ext cx="763" cy="144000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Conector recto de flecha 152"/>
          <p:cNvCxnSpPr/>
          <p:nvPr/>
        </p:nvCxnSpPr>
        <p:spPr>
          <a:xfrm flipV="1">
            <a:off x="2338426" y="1657455"/>
            <a:ext cx="763" cy="144000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Conector recto de flecha 153"/>
          <p:cNvCxnSpPr/>
          <p:nvPr/>
        </p:nvCxnSpPr>
        <p:spPr>
          <a:xfrm flipV="1">
            <a:off x="2007617" y="1657628"/>
            <a:ext cx="763" cy="144000"/>
          </a:xfrm>
          <a:prstGeom prst="straightConnector1">
            <a:avLst/>
          </a:prstGeom>
          <a:ln w="12700">
            <a:solidFill>
              <a:schemeClr val="tx1"/>
            </a:solidFill>
            <a:prstDash val="solid"/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Cerrar corchete 154"/>
          <p:cNvSpPr/>
          <p:nvPr/>
        </p:nvSpPr>
        <p:spPr>
          <a:xfrm rot="16200000">
            <a:off x="2146144" y="1219491"/>
            <a:ext cx="45719" cy="596123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56" name="Cerrar corchete 155"/>
          <p:cNvSpPr/>
          <p:nvPr/>
        </p:nvSpPr>
        <p:spPr>
          <a:xfrm rot="16200000">
            <a:off x="3077268" y="953641"/>
            <a:ext cx="49174" cy="1137203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57" name="Cerrar corchete 156"/>
          <p:cNvSpPr/>
          <p:nvPr/>
        </p:nvSpPr>
        <p:spPr>
          <a:xfrm rot="16200000">
            <a:off x="3906872" y="1304932"/>
            <a:ext cx="48371" cy="435426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59" name="CuadroTexto 158"/>
          <p:cNvSpPr txBox="1"/>
          <p:nvPr/>
        </p:nvSpPr>
        <p:spPr>
          <a:xfrm>
            <a:off x="771929" y="1511909"/>
            <a:ext cx="733773" cy="2154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s-E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les</a:t>
            </a:r>
            <a:endParaRPr lang="es-E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Cerrar corchete 112"/>
          <p:cNvSpPr/>
          <p:nvPr/>
        </p:nvSpPr>
        <p:spPr>
          <a:xfrm rot="16200000">
            <a:off x="5422385" y="5009355"/>
            <a:ext cx="49786" cy="38672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5" name="Cerrar corchete 114"/>
          <p:cNvSpPr/>
          <p:nvPr/>
        </p:nvSpPr>
        <p:spPr>
          <a:xfrm rot="16200000">
            <a:off x="5845265" y="5011385"/>
            <a:ext cx="49786" cy="386720"/>
          </a:xfrm>
          <a:prstGeom prst="rightBracket">
            <a:avLst/>
          </a:prstGeom>
          <a:noFill/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1" name="CuadroTexto 120"/>
          <p:cNvSpPr txBox="1"/>
          <p:nvPr/>
        </p:nvSpPr>
        <p:spPr>
          <a:xfrm>
            <a:off x="365988" y="477645"/>
            <a:ext cx="31307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es-E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S3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57248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62</TotalTime>
  <Words>37</Words>
  <Application>Microsoft Office PowerPoint</Application>
  <PresentationFormat>A4 (210 x 297 mm)</PresentationFormat>
  <Paragraphs>33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